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2520" y="-2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19.11.2021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90100"/>
            <a:ext cx="507767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US" altLang="ru-RU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1. The number of genes and </a:t>
            </a:r>
            <a:r>
              <a:rPr lang="en-US" altLang="ru-RU" sz="1200" b="1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ircRNAs</a:t>
            </a:r>
            <a:r>
              <a:rPr lang="en-US" altLang="ru-RU" sz="1200" b="1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that were encoded by </a:t>
            </a:r>
            <a:r>
              <a:rPr lang="en-US" altLang="ru-RU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them</a:t>
            </a:r>
            <a:endParaRPr lang="en-US" altLang="ru-RU" sz="1200" b="1" dirty="0">
              <a:latin typeface="Times New Roman" pitchFamily="18" charset="0"/>
              <a:ea typeface="Calibri" pitchFamily="34" charset="0"/>
              <a:cs typeface="Times New Roman" pitchFamily="18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95986" y="4509120"/>
            <a:ext cx="8915720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228600" lvl="0" indent="-228600" fontAlgn="base">
              <a:spcBef>
                <a:spcPct val="0"/>
              </a:spcBef>
              <a:spcAft>
                <a:spcPct val="0"/>
              </a:spcAft>
              <a:buAutoNum type="alphaLcParenBoth"/>
            </a:pPr>
            <a:r>
              <a:rPr lang="en-US" altLang="ru-RU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ll 11,106 </a:t>
            </a:r>
            <a:r>
              <a:rPr lang="en-US" altLang="ru-RU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dentified </a:t>
            </a:r>
            <a:r>
              <a:rPr lang="en-US" altLang="ru-RU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ircRNAs</a:t>
            </a:r>
            <a:r>
              <a:rPr lang="en-US" altLang="ru-RU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were </a:t>
            </a:r>
            <a:r>
              <a:rPr lang="en-US" altLang="ru-RU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alysed</a:t>
            </a:r>
            <a:r>
              <a:rPr lang="en-US" altLang="ru-RU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(</a:t>
            </a:r>
            <a:r>
              <a:rPr lang="en-US" altLang="ru-RU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) Only 395 DECs were </a:t>
            </a:r>
            <a:r>
              <a:rPr lang="en-US" altLang="ru-RU" sz="1200" dirty="0" err="1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nalysed</a:t>
            </a:r>
            <a:r>
              <a:rPr lang="en-US" altLang="ru-RU" sz="1200" dirty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</a:t>
            </a:r>
          </a:p>
        </p:txBody>
      </p:sp>
      <p:pic>
        <p:nvPicPr>
          <p:cNvPr id="1026" name="Picture 2" descr="J:\Редактируемые\Для публикаций\0_текущие публикации\микро и циклоРНК\статья по циклоРНК при ишемии\в журналы\5_Genes\на отправку\раунд 1\FigureS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359297"/>
            <a:ext cx="8832194" cy="26457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6396546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30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5</cp:revision>
  <dcterms:created xsi:type="dcterms:W3CDTF">2020-12-07T15:35:27Z</dcterms:created>
  <dcterms:modified xsi:type="dcterms:W3CDTF">2021-11-19T16:03:37Z</dcterms:modified>
</cp:coreProperties>
</file>